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75" r:id="rId2"/>
  </p:sldIdLst>
  <p:sldSz cx="6840538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0432FF"/>
    <a:srgbClr val="654B4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3289"/>
    <p:restoredTop sz="94651"/>
  </p:normalViewPr>
  <p:slideViewPr>
    <p:cSldViewPr snapToGrid="0">
      <p:cViewPr varScale="1">
        <p:scale>
          <a:sx n="91" d="100"/>
          <a:sy n="91" d="100"/>
        </p:scale>
        <p:origin x="263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415E46-7790-044A-9762-68807AD201AC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8213" y="1143000"/>
            <a:ext cx="2441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A2C18D-D97C-FE4F-8227-06E7E77C1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0648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C76C87A-5ECB-554D-EAD5-81BFC63D21F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63F67068-33FA-DB97-4F66-4E8818FC88D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7C4D0896-4116-391B-062A-7077CC785F5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55738CD-5715-DF96-1C86-870EC5D535D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FA2C18D-D97C-FE4F-8227-06E7E77C1E3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9930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414125"/>
            <a:ext cx="5814457" cy="3008266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538401"/>
            <a:ext cx="5130404" cy="2086184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185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7041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60041"/>
            <a:ext cx="1474991" cy="732264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60041"/>
            <a:ext cx="4339466" cy="732264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365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022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154193"/>
            <a:ext cx="5899964" cy="3594317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5782513"/>
            <a:ext cx="5899964" cy="1890166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>
                    <a:tint val="82000"/>
                  </a:schemeClr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82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82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942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300203"/>
            <a:ext cx="2907229" cy="54824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300203"/>
            <a:ext cx="2907229" cy="54824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081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60043"/>
            <a:ext cx="5899964" cy="167014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118188"/>
            <a:ext cx="2893868" cy="1038091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156278"/>
            <a:ext cx="2893868" cy="46424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118188"/>
            <a:ext cx="2908120" cy="1038091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156278"/>
            <a:ext cx="2908120" cy="46424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424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92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475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76051"/>
            <a:ext cx="2206252" cy="201617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244112"/>
            <a:ext cx="3463022" cy="6140542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592229"/>
            <a:ext cx="2206252" cy="4802425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96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76051"/>
            <a:ext cx="2206252" cy="201617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244112"/>
            <a:ext cx="3463022" cy="6140542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592229"/>
            <a:ext cx="2206252" cy="4802425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534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60043"/>
            <a:ext cx="5899964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300203"/>
            <a:ext cx="5899964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8008709"/>
            <a:ext cx="1539121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8008709"/>
            <a:ext cx="2308682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8008709"/>
            <a:ext cx="1539121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190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5B50ABA-18AC-6392-AEE2-522C054DE1B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D32B6893-BDC3-7E9C-86DD-6476FBD1A5B4}"/>
              </a:ext>
            </a:extLst>
          </p:cNvPr>
          <p:cNvSpPr txBox="1"/>
          <p:nvPr/>
        </p:nvSpPr>
        <p:spPr>
          <a:xfrm>
            <a:off x="723531" y="5697907"/>
            <a:ext cx="82747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Δ </a:t>
            </a:r>
            <a:r>
              <a:rPr lang="en-CA" sz="700" b="1" dirty="0" err="1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NfL</a:t>
            </a:r>
            <a:r>
              <a:rPr lang="en-CA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Z-score</a:t>
            </a:r>
            <a:endParaRPr lang="en-CA" sz="700" dirty="0">
              <a:solidFill>
                <a:srgbClr val="18191B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72149E7-4490-B09E-A186-E824DCF264D3}"/>
              </a:ext>
            </a:extLst>
          </p:cNvPr>
          <p:cNvSpPr txBox="1"/>
          <p:nvPr/>
        </p:nvSpPr>
        <p:spPr>
          <a:xfrm rot="16200000">
            <a:off x="-197974" y="4651385"/>
            <a:ext cx="8217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D14+ EVs</a:t>
            </a:r>
            <a:endParaRPr lang="en-CA" sz="700" dirty="0">
              <a:solidFill>
                <a:srgbClr val="18191B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73A5B19-6082-66AD-4540-5C9C2721A28A}"/>
              </a:ext>
            </a:extLst>
          </p:cNvPr>
          <p:cNvSpPr txBox="1"/>
          <p:nvPr/>
        </p:nvSpPr>
        <p:spPr>
          <a:xfrm>
            <a:off x="2937939" y="5701158"/>
            <a:ext cx="94506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Δ </a:t>
            </a:r>
            <a:r>
              <a:rPr lang="en-CA" sz="700" b="1" dirty="0" err="1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NfL</a:t>
            </a:r>
            <a:r>
              <a:rPr lang="en-CA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Z-score</a:t>
            </a:r>
            <a:endParaRPr lang="en-CA" sz="700" dirty="0">
              <a:solidFill>
                <a:srgbClr val="18191B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8F524C7-5413-74CB-BC2A-94CADB14757C}"/>
              </a:ext>
            </a:extLst>
          </p:cNvPr>
          <p:cNvSpPr txBox="1"/>
          <p:nvPr/>
        </p:nvSpPr>
        <p:spPr>
          <a:xfrm>
            <a:off x="5269938" y="5697906"/>
            <a:ext cx="82747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Δ </a:t>
            </a:r>
            <a:r>
              <a:rPr lang="en-CA" sz="700" b="1" dirty="0" err="1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NfL</a:t>
            </a:r>
            <a:r>
              <a:rPr lang="en-CA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Z-score</a:t>
            </a:r>
            <a:endParaRPr lang="en-CA" sz="700" dirty="0">
              <a:solidFill>
                <a:srgbClr val="18191B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9106DF91-9A6F-9DE9-D328-37C4B6818B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1781" y="721689"/>
            <a:ext cx="6418757" cy="2893880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ACF0D414-1C34-DCCC-5700-9E0DA46C31D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2869" y="3970998"/>
            <a:ext cx="2321136" cy="1728000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658B6675-19E7-1DE1-4F7E-7CF230B7D91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74804" y="3957496"/>
            <a:ext cx="2321134" cy="1728000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B14EB2A1-6503-AB7E-F205-7EABC0EE7CC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95938" y="3957496"/>
            <a:ext cx="2321136" cy="1728000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C49D0C4D-C608-ADAE-9AC5-9932CE8016AE}"/>
              </a:ext>
            </a:extLst>
          </p:cNvPr>
          <p:cNvSpPr txBox="1"/>
          <p:nvPr/>
        </p:nvSpPr>
        <p:spPr>
          <a:xfrm>
            <a:off x="1270316" y="4174878"/>
            <a:ext cx="5613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r=-0.221</a:t>
            </a:r>
          </a:p>
          <a:p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=0.6031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3B3D09F-47C2-6553-E306-814ABC7074DF}"/>
              </a:ext>
            </a:extLst>
          </p:cNvPr>
          <p:cNvSpPr txBox="1"/>
          <p:nvPr/>
        </p:nvSpPr>
        <p:spPr>
          <a:xfrm>
            <a:off x="3699660" y="4035243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r=-0.3692</a:t>
            </a:r>
          </a:p>
          <a:p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=0.3181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ED54D44-60D8-9DE6-943A-D7C722DE6E9A}"/>
              </a:ext>
            </a:extLst>
          </p:cNvPr>
          <p:cNvSpPr txBox="1"/>
          <p:nvPr/>
        </p:nvSpPr>
        <p:spPr>
          <a:xfrm>
            <a:off x="6083564" y="3983898"/>
            <a:ext cx="5613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r=0.1837</a:t>
            </a:r>
          </a:p>
          <a:p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=0.4515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AE610EC-1967-E10F-399B-93ACF18E6439}"/>
              </a:ext>
            </a:extLst>
          </p:cNvPr>
          <p:cNvSpPr txBox="1"/>
          <p:nvPr/>
        </p:nvSpPr>
        <p:spPr>
          <a:xfrm>
            <a:off x="35890" y="418802"/>
            <a:ext cx="3962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D0954DA8-5010-86B8-3954-0287E801E17E}"/>
              </a:ext>
            </a:extLst>
          </p:cNvPr>
          <p:cNvSpPr txBox="1"/>
          <p:nvPr/>
        </p:nvSpPr>
        <p:spPr>
          <a:xfrm>
            <a:off x="0" y="3700351"/>
            <a:ext cx="3962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6C6221C-708B-61A1-CA87-C967C6D4A9B2}"/>
              </a:ext>
            </a:extLst>
          </p:cNvPr>
          <p:cNvSpPr txBox="1"/>
          <p:nvPr/>
        </p:nvSpPr>
        <p:spPr>
          <a:xfrm rot="16200000">
            <a:off x="2100467" y="4705246"/>
            <a:ext cx="77370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D19+ EVs</a:t>
            </a:r>
            <a:endParaRPr lang="en-CA" sz="700" dirty="0">
              <a:solidFill>
                <a:srgbClr val="18191B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D88BD4D-B35B-B7A4-0A6C-5506A30FE05B}"/>
              </a:ext>
            </a:extLst>
          </p:cNvPr>
          <p:cNvSpPr txBox="1"/>
          <p:nvPr/>
        </p:nvSpPr>
        <p:spPr>
          <a:xfrm rot="16200000">
            <a:off x="4378764" y="4705245"/>
            <a:ext cx="8593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D45+ EVs</a:t>
            </a:r>
            <a:endParaRPr lang="en-CA" sz="700" dirty="0">
              <a:solidFill>
                <a:srgbClr val="18191B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079926A-ED3F-6EC4-C226-B3C632BFFFCD}"/>
              </a:ext>
            </a:extLst>
          </p:cNvPr>
          <p:cNvSpPr txBox="1"/>
          <p:nvPr/>
        </p:nvSpPr>
        <p:spPr>
          <a:xfrm>
            <a:off x="198112" y="103204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9138BC2-4055-C80E-664C-953C5BA6746D}"/>
              </a:ext>
            </a:extLst>
          </p:cNvPr>
          <p:cNvSpPr txBox="1"/>
          <p:nvPr/>
        </p:nvSpPr>
        <p:spPr>
          <a:xfrm>
            <a:off x="733433" y="3721883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 EV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335C44E-FA54-C54F-A2DD-C754EC3481AD}"/>
              </a:ext>
            </a:extLst>
          </p:cNvPr>
          <p:cNvSpPr txBox="1"/>
          <p:nvPr/>
        </p:nvSpPr>
        <p:spPr>
          <a:xfrm>
            <a:off x="2894283" y="3711275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9 EV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2F8BD6F-D81C-1D50-B9CA-216EC9EF9094}"/>
              </a:ext>
            </a:extLst>
          </p:cNvPr>
          <p:cNvSpPr txBox="1"/>
          <p:nvPr/>
        </p:nvSpPr>
        <p:spPr>
          <a:xfrm>
            <a:off x="5269938" y="3721882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5 EV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D16825E-FB4B-4343-F0A3-21346B21848A}"/>
              </a:ext>
            </a:extLst>
          </p:cNvPr>
          <p:cNvSpPr txBox="1"/>
          <p:nvPr/>
        </p:nvSpPr>
        <p:spPr>
          <a:xfrm rot="16200000">
            <a:off x="-751845" y="1911646"/>
            <a:ext cx="2194832" cy="2231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5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tio (CD14 or CD19/CD45; CD45/CD9)</a:t>
            </a:r>
          </a:p>
        </p:txBody>
      </p:sp>
    </p:spTree>
    <p:extLst>
      <p:ext uri="{BB962C8B-B14F-4D97-AF65-F5344CB8AC3E}">
        <p14:creationId xmlns:p14="http://schemas.microsoft.com/office/powerpoint/2010/main" val="1793570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4</TotalTime>
  <Words>63</Words>
  <Application>Microsoft Macintosh PowerPoint</Application>
  <PresentationFormat>Custom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ennifer Leigh Zagrodnik</dc:creator>
  <cp:lastModifiedBy>Moore, Craig S.</cp:lastModifiedBy>
  <cp:revision>29</cp:revision>
  <cp:lastPrinted>2024-10-15T17:54:31Z</cp:lastPrinted>
  <dcterms:created xsi:type="dcterms:W3CDTF">2024-10-10T14:11:55Z</dcterms:created>
  <dcterms:modified xsi:type="dcterms:W3CDTF">2024-12-20T19:18:24Z</dcterms:modified>
</cp:coreProperties>
</file>